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70C251-0B89-152E-C5F5-275B6F6137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B3095FC-7DED-70D4-532D-C402C7932A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EBD17F-06D4-357D-49FB-446A71BC5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446E29-CD1B-DD16-81FA-A69E52E8F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E03728C-8C22-95A3-37C4-DED570ECE2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56154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303F3B-8625-A515-7800-3A68B8739D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A77C145-A6D7-5D7E-0A11-DF3FB22469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3B52732-8A58-2B53-7AB0-0EAF2AE342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A998AB-A1DF-75AF-CE4C-50E30239F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C46D5B-7FE3-47B9-F966-6293C924A0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7991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EDE8ACF-E76A-84DB-3A82-DD4C2197DC0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54289A9-40D2-C7A3-6E54-D99EA894C6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BB78AA3-623F-9393-4FAA-3887166C80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EC7DCE4-D4C0-EF83-1581-96BBCE870A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47968D8-F73F-353E-7856-F572FE34F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1164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CBFC35-7927-41DF-DADA-A9D0C25496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D5F7E8-198B-644E-4B7F-C781B392F5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8AAC4D1-FD15-E066-5889-34BC9D0827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69BE458-2CCB-C7F0-98B5-4CFA4F738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4C180F-9AE3-DD8A-2C28-3DDF7A0B7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98794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CC6F54-4FF8-9A88-1CA4-C03AADC47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5055222-5FFF-2B22-8077-B7961CACC9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9EF6E6-5004-AAA0-1F26-24E060B43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24C39F5-4CC9-831A-B7C7-AADE005756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5A1589-58F5-F465-0465-3BCF53FEA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9440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C9FB8BC-4D4B-0A3B-003B-9C347CFD97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0F7DBE9-A538-C765-A6A4-876A3646963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C58D7FA-8E7E-FA91-7252-73B717AE2D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8DC171E-28CE-A988-FAC8-38F757E92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46BD07F-F401-4F80-96C3-E73119D1B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D9A640F-1A9C-FAD0-DD84-ED445B21E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7571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8E1ECED-3DC7-2C9A-73B3-0FB60568CA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7119FD-ED7B-11C3-5FBD-52C4035F85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E841CC9-F745-C4D4-3FEE-72DDA8074D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08460E1-7FDE-5BD3-2458-CBC46605D6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CBE33EE-CB35-0FDD-613A-544B96B222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21B0B38-9508-6E7F-B802-2416B57EB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747C698-4E8D-A601-89C8-870EC575D9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97750C8-EB16-D2E9-B541-D9529E591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9452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389932-86A4-BD95-2936-B83EAE76CB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5075E74-C2EB-C84D-D181-1E0ABC82BF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C00AADA-FFEC-941F-E29E-3CD39FE2AA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D2D1108-3C07-782C-C94D-D85812380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1971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C9D902B-7494-C2F7-8A88-F8F974389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5C6FC20-AAA3-EFA4-1BB9-1E58B1691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C42226E-1682-765B-25EE-75D4BF7D4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09686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BCF431-AD8F-621A-0D09-0A3BF1856D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30F456C-B9E5-4341-7BA3-6AF272CBD75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7EB67B2-D69F-29ED-2603-15C705A79A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B86B800-B6BB-9D57-CFA2-27548DFA1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E5F57D5-62B2-C363-A25F-F888DD8D7C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07959F4-BA63-4091-8F3D-0A878F07DC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5753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BCD858-7C5A-2F54-03BB-FCF53FD41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BCC50D5-71FC-67A9-1256-C2D48DD2043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6783B49-0F0B-54CC-9E7E-7EA254E94C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5CB7724-FB25-2A5E-1162-A6162936A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03AF79D-5080-BDF8-46B1-96C7A9B1F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EC225D5-7000-449D-4147-E9F38D7C7E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4947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DE3ADE2-EE62-E44C-72B9-84BB2B0FD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C62955F-3D0F-9F0C-CF1A-A04580B275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11F2B4-1133-8965-935B-CED3ECFA3F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A2C908-6728-4247-A9BD-280C0555B523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A3F8213-7B68-D461-DC8B-C1282D3CAD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356C1F1-72E0-E791-24DA-FCDB937498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DB25F-76B8-4C65-9FB4-1EA4F5FCDC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73170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>
            <a:extLst>
              <a:ext uri="{FF2B5EF4-FFF2-40B4-BE49-F238E27FC236}">
                <a16:creationId xmlns:a16="http://schemas.microsoft.com/office/drawing/2014/main" id="{FBE2ADB7-8FD2-BD77-894F-3A4D305082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23" t="38044" r="22011" b="35709"/>
          <a:stretch/>
        </p:blipFill>
        <p:spPr>
          <a:xfrm>
            <a:off x="3996024" y="2518231"/>
            <a:ext cx="5452770" cy="1874245"/>
          </a:xfrm>
          <a:prstGeom prst="rect">
            <a:avLst/>
          </a:prstGeom>
        </p:spPr>
      </p:pic>
      <p:grpSp>
        <p:nvGrpSpPr>
          <p:cNvPr id="20" name="Group 43">
            <a:extLst>
              <a:ext uri="{FF2B5EF4-FFF2-40B4-BE49-F238E27FC236}">
                <a16:creationId xmlns:a16="http://schemas.microsoft.com/office/drawing/2014/main" id="{583E3E4F-102E-1348-72A2-92D1B0235B4C}"/>
              </a:ext>
            </a:extLst>
          </p:cNvPr>
          <p:cNvGrpSpPr/>
          <p:nvPr/>
        </p:nvGrpSpPr>
        <p:grpSpPr>
          <a:xfrm>
            <a:off x="2678261" y="1904370"/>
            <a:ext cx="7469103" cy="2070791"/>
            <a:chOff x="-1799860" y="6153712"/>
            <a:chExt cx="7469103" cy="2070791"/>
          </a:xfrm>
        </p:grpSpPr>
        <p:sp>
          <p:nvSpPr>
            <p:cNvPr id="21" name="文本框 31">
              <a:extLst>
                <a:ext uri="{FF2B5EF4-FFF2-40B4-BE49-F238E27FC236}">
                  <a16:creationId xmlns:a16="http://schemas.microsoft.com/office/drawing/2014/main" id="{9F4ADAA5-250E-4E07-90F5-2963A1A398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20268" y="7946691"/>
              <a:ext cx="944217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ea typeface="黑体" panose="02010609060101010101" pitchFamily="49" charset="-122"/>
                  <a:cs typeface="Arial" panose="020B0604020202020204" pitchFamily="34" charset="0"/>
                </a:rPr>
                <a:t>His6</a:t>
              </a:r>
              <a:endParaRPr lang="zh-CN" altLang="en-US" sz="1200" dirty="0"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grpSp>
          <p:nvGrpSpPr>
            <p:cNvPr id="22" name="Group 152">
              <a:extLst>
                <a:ext uri="{FF2B5EF4-FFF2-40B4-BE49-F238E27FC236}">
                  <a16:creationId xmlns:a16="http://schemas.microsoft.com/office/drawing/2014/main" id="{7A44C044-E1F8-618A-6A04-09676950EEB9}"/>
                </a:ext>
              </a:extLst>
            </p:cNvPr>
            <p:cNvGrpSpPr/>
            <p:nvPr/>
          </p:nvGrpSpPr>
          <p:grpSpPr>
            <a:xfrm>
              <a:off x="-1082038" y="6765411"/>
              <a:ext cx="661675" cy="276999"/>
              <a:chOff x="-858885" y="6632801"/>
              <a:chExt cx="661675" cy="276999"/>
            </a:xfrm>
          </p:grpSpPr>
          <p:sp>
            <p:nvSpPr>
              <p:cNvPr id="29" name="文本框 49">
                <a:extLst>
                  <a:ext uri="{FF2B5EF4-FFF2-40B4-BE49-F238E27FC236}">
                    <a16:creationId xmlns:a16="http://schemas.microsoft.com/office/drawing/2014/main" id="{9E9380D6-5726-D427-A692-592C7A786388}"/>
                  </a:ext>
                </a:extLst>
              </p:cNvPr>
              <p:cNvSpPr txBox="1"/>
              <p:nvPr/>
            </p:nvSpPr>
            <p:spPr>
              <a:xfrm>
                <a:off x="-840899" y="6632801"/>
                <a:ext cx="643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MW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30" name="直接连接符 63">
                <a:extLst>
                  <a:ext uri="{FF2B5EF4-FFF2-40B4-BE49-F238E27FC236}">
                    <a16:creationId xmlns:a16="http://schemas.microsoft.com/office/drawing/2014/main" id="{63C34E94-637F-B1D2-08DD-FDEEAD37858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858885" y="6855791"/>
                <a:ext cx="457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oup 153">
              <a:extLst>
                <a:ext uri="{FF2B5EF4-FFF2-40B4-BE49-F238E27FC236}">
                  <a16:creationId xmlns:a16="http://schemas.microsoft.com/office/drawing/2014/main" id="{D82DE9F6-F1B9-2728-3CB4-1B4ED14F38FE}"/>
                </a:ext>
              </a:extLst>
            </p:cNvPr>
            <p:cNvGrpSpPr/>
            <p:nvPr/>
          </p:nvGrpSpPr>
          <p:grpSpPr>
            <a:xfrm>
              <a:off x="4979950" y="6786342"/>
              <a:ext cx="689293" cy="276999"/>
              <a:chOff x="7617180" y="6644793"/>
              <a:chExt cx="689293" cy="276999"/>
            </a:xfrm>
          </p:grpSpPr>
          <p:sp>
            <p:nvSpPr>
              <p:cNvPr id="27" name="文本框 49">
                <a:extLst>
                  <a:ext uri="{FF2B5EF4-FFF2-40B4-BE49-F238E27FC236}">
                    <a16:creationId xmlns:a16="http://schemas.microsoft.com/office/drawing/2014/main" id="{E0E8EB97-EA70-0835-5AF5-F2C048BD1C2D}"/>
                  </a:ext>
                </a:extLst>
              </p:cNvPr>
              <p:cNvSpPr txBox="1"/>
              <p:nvPr/>
            </p:nvSpPr>
            <p:spPr>
              <a:xfrm>
                <a:off x="7662784" y="6644793"/>
                <a:ext cx="643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Ab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28" name="直接连接符 63">
                <a:extLst>
                  <a:ext uri="{FF2B5EF4-FFF2-40B4-BE49-F238E27FC236}">
                    <a16:creationId xmlns:a16="http://schemas.microsoft.com/office/drawing/2014/main" id="{7223DFAB-73F8-E639-939E-5D01B375977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617180" y="6877634"/>
                <a:ext cx="457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4" name="文本框 29">
              <a:extLst>
                <a:ext uri="{FF2B5EF4-FFF2-40B4-BE49-F238E27FC236}">
                  <a16:creationId xmlns:a16="http://schemas.microsoft.com/office/drawing/2014/main" id="{F038119A-7AF3-9850-BF72-FF13116F4BCC}"/>
                </a:ext>
              </a:extLst>
            </p:cNvPr>
            <p:cNvSpPr txBox="1"/>
            <p:nvPr/>
          </p:nvSpPr>
          <p:spPr>
            <a:xfrm>
              <a:off x="1337931" y="6181358"/>
              <a:ext cx="196612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+       +          -         +     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+       -          +  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-       +          -         +</a:t>
              </a:r>
            </a:p>
          </p:txBody>
        </p:sp>
        <p:sp>
          <p:nvSpPr>
            <p:cNvPr id="25" name="文本框 29">
              <a:extLst>
                <a:ext uri="{FF2B5EF4-FFF2-40B4-BE49-F238E27FC236}">
                  <a16:creationId xmlns:a16="http://schemas.microsoft.com/office/drawing/2014/main" id="{88ABF590-71BB-E3E3-671D-5310E1B020E2}"/>
                </a:ext>
              </a:extLst>
            </p:cNvPr>
            <p:cNvSpPr txBox="1"/>
            <p:nvPr/>
          </p:nvSpPr>
          <p:spPr>
            <a:xfrm>
              <a:off x="-1799860" y="6153712"/>
              <a:ext cx="166809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 beads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is-p53</a:t>
              </a:r>
              <a:r>
                <a:rPr lang="en-US" altLang="zh-CN" sz="1200" baseline="300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15-29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-Mdm2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-CTD</a:t>
              </a:r>
            </a:p>
          </p:txBody>
        </p:sp>
        <p:cxnSp>
          <p:nvCxnSpPr>
            <p:cNvPr id="26" name="直接连接符 63">
              <a:extLst>
                <a:ext uri="{FF2B5EF4-FFF2-40B4-BE49-F238E27FC236}">
                  <a16:creationId xmlns:a16="http://schemas.microsoft.com/office/drawing/2014/main" id="{7351B5C4-2A8C-10B8-26C2-0D00AC38C454}"/>
                </a:ext>
              </a:extLst>
            </p:cNvPr>
            <p:cNvCxnSpPr>
              <a:cxnSpLocks/>
            </p:cNvCxnSpPr>
            <p:nvPr/>
          </p:nvCxnSpPr>
          <p:spPr>
            <a:xfrm>
              <a:off x="1183372" y="6163267"/>
              <a:ext cx="19202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" name="文本框 30">
            <a:extLst>
              <a:ext uri="{FF2B5EF4-FFF2-40B4-BE49-F238E27FC236}">
                <a16:creationId xmlns:a16="http://schemas.microsoft.com/office/drawing/2014/main" id="{A2A94D93-5FEE-B065-1548-BAA84D2B7A22}"/>
              </a:ext>
            </a:extLst>
          </p:cNvPr>
          <p:cNvSpPr txBox="1"/>
          <p:nvPr/>
        </p:nvSpPr>
        <p:spPr>
          <a:xfrm>
            <a:off x="3414069" y="318598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FF27D75-2910-1450-9EDC-7EC8373796E6}"/>
              </a:ext>
            </a:extLst>
          </p:cNvPr>
          <p:cNvSpPr txBox="1"/>
          <p:nvPr/>
        </p:nvSpPr>
        <p:spPr>
          <a:xfrm>
            <a:off x="3414069" y="306322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C08239C-1F21-1919-BC38-123548A3AB72}"/>
              </a:ext>
            </a:extLst>
          </p:cNvPr>
          <p:cNvSpPr txBox="1"/>
          <p:nvPr/>
        </p:nvSpPr>
        <p:spPr>
          <a:xfrm>
            <a:off x="3414069" y="330952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12E0759-11B8-7DE1-EEE2-3571B079ACD8}"/>
              </a:ext>
            </a:extLst>
          </p:cNvPr>
          <p:cNvSpPr txBox="1"/>
          <p:nvPr/>
        </p:nvSpPr>
        <p:spPr>
          <a:xfrm>
            <a:off x="3414069" y="350473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D7B7BB9-F164-8130-A1F5-CD193BCA309F}"/>
              </a:ext>
            </a:extLst>
          </p:cNvPr>
          <p:cNvSpPr txBox="1"/>
          <p:nvPr/>
        </p:nvSpPr>
        <p:spPr>
          <a:xfrm>
            <a:off x="3396083" y="379851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C8F61CD-B34F-2EE0-6935-6F43A8CB88E0}"/>
              </a:ext>
            </a:extLst>
          </p:cNvPr>
          <p:cNvSpPr txBox="1"/>
          <p:nvPr/>
        </p:nvSpPr>
        <p:spPr>
          <a:xfrm>
            <a:off x="3387222" y="404088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0EBAACE7-DCED-88BE-84BD-AF52730FF0AB}"/>
              </a:ext>
            </a:extLst>
          </p:cNvPr>
          <p:cNvSpPr txBox="1"/>
          <p:nvPr/>
        </p:nvSpPr>
        <p:spPr>
          <a:xfrm>
            <a:off x="3414069" y="292212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99059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43">
            <a:extLst>
              <a:ext uri="{FF2B5EF4-FFF2-40B4-BE49-F238E27FC236}">
                <a16:creationId xmlns:a16="http://schemas.microsoft.com/office/drawing/2014/main" id="{10278DC6-F1C1-DD9D-8B21-A18E61543F17}"/>
              </a:ext>
            </a:extLst>
          </p:cNvPr>
          <p:cNvGrpSpPr/>
          <p:nvPr/>
        </p:nvGrpSpPr>
        <p:grpSpPr>
          <a:xfrm>
            <a:off x="2409747" y="1657628"/>
            <a:ext cx="7716817" cy="2552824"/>
            <a:chOff x="-1799860" y="6153712"/>
            <a:chExt cx="7716817" cy="2552824"/>
          </a:xfrm>
        </p:grpSpPr>
        <p:sp>
          <p:nvSpPr>
            <p:cNvPr id="4" name="文本框 31">
              <a:extLst>
                <a:ext uri="{FF2B5EF4-FFF2-40B4-BE49-F238E27FC236}">
                  <a16:creationId xmlns:a16="http://schemas.microsoft.com/office/drawing/2014/main" id="{6090B568-A087-55CC-B4B0-F479FE3F2D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650896" y="8428724"/>
              <a:ext cx="944217" cy="2778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algn="r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ea typeface="黑体" panose="02010609060101010101" pitchFamily="49" charset="-122"/>
                  <a:cs typeface="Arial" panose="020B0604020202020204" pitchFamily="34" charset="0"/>
                </a:rPr>
                <a:t>p53</a:t>
              </a:r>
              <a:endParaRPr lang="zh-CN" altLang="en-US" sz="1200" dirty="0"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grpSp>
          <p:nvGrpSpPr>
            <p:cNvPr id="5" name="Group 152">
              <a:extLst>
                <a:ext uri="{FF2B5EF4-FFF2-40B4-BE49-F238E27FC236}">
                  <a16:creationId xmlns:a16="http://schemas.microsoft.com/office/drawing/2014/main" id="{C2AC8AA2-BA83-4B7E-FC3A-F0AB253B2B99}"/>
                </a:ext>
              </a:extLst>
            </p:cNvPr>
            <p:cNvGrpSpPr/>
            <p:nvPr/>
          </p:nvGrpSpPr>
          <p:grpSpPr>
            <a:xfrm>
              <a:off x="-1082038" y="6765411"/>
              <a:ext cx="661675" cy="276999"/>
              <a:chOff x="-858885" y="6632801"/>
              <a:chExt cx="661675" cy="276999"/>
            </a:xfrm>
          </p:grpSpPr>
          <p:sp>
            <p:nvSpPr>
              <p:cNvPr id="12" name="文本框 49">
                <a:extLst>
                  <a:ext uri="{FF2B5EF4-FFF2-40B4-BE49-F238E27FC236}">
                    <a16:creationId xmlns:a16="http://schemas.microsoft.com/office/drawing/2014/main" id="{029E0471-2997-6238-2B4D-5496F772032C}"/>
                  </a:ext>
                </a:extLst>
              </p:cNvPr>
              <p:cNvSpPr txBox="1"/>
              <p:nvPr/>
            </p:nvSpPr>
            <p:spPr>
              <a:xfrm>
                <a:off x="-840899" y="6632801"/>
                <a:ext cx="643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MW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3" name="直接连接符 63">
                <a:extLst>
                  <a:ext uri="{FF2B5EF4-FFF2-40B4-BE49-F238E27FC236}">
                    <a16:creationId xmlns:a16="http://schemas.microsoft.com/office/drawing/2014/main" id="{334D2373-FAE4-B9F6-F9B6-0B23E3E10E1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-858885" y="6855791"/>
                <a:ext cx="457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oup 153">
              <a:extLst>
                <a:ext uri="{FF2B5EF4-FFF2-40B4-BE49-F238E27FC236}">
                  <a16:creationId xmlns:a16="http://schemas.microsoft.com/office/drawing/2014/main" id="{DEFFB2D5-146E-4E4E-2665-6922EF5F2D96}"/>
                </a:ext>
              </a:extLst>
            </p:cNvPr>
            <p:cNvGrpSpPr/>
            <p:nvPr/>
          </p:nvGrpSpPr>
          <p:grpSpPr>
            <a:xfrm>
              <a:off x="5212043" y="6796230"/>
              <a:ext cx="704914" cy="276999"/>
              <a:chOff x="7849273" y="6654681"/>
              <a:chExt cx="704914" cy="276999"/>
            </a:xfrm>
          </p:grpSpPr>
          <p:sp>
            <p:nvSpPr>
              <p:cNvPr id="10" name="文本框 49">
                <a:extLst>
                  <a:ext uri="{FF2B5EF4-FFF2-40B4-BE49-F238E27FC236}">
                    <a16:creationId xmlns:a16="http://schemas.microsoft.com/office/drawing/2014/main" id="{E4441FE8-BCAF-EB22-E6AF-744964DF0048}"/>
                  </a:ext>
                </a:extLst>
              </p:cNvPr>
              <p:cNvSpPr txBox="1"/>
              <p:nvPr/>
            </p:nvSpPr>
            <p:spPr>
              <a:xfrm>
                <a:off x="7910498" y="6654681"/>
                <a:ext cx="64368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ea typeface="黑体" panose="02010609060101010101" pitchFamily="49" charset="-122"/>
                    <a:cs typeface="Arial" panose="020B0604020202020204" pitchFamily="34" charset="0"/>
                  </a:rPr>
                  <a:t>Ab</a:t>
                </a:r>
                <a:endParaRPr lang="zh-CN" altLang="en-US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1" name="直接连接符 63">
                <a:extLst>
                  <a:ext uri="{FF2B5EF4-FFF2-40B4-BE49-F238E27FC236}">
                    <a16:creationId xmlns:a16="http://schemas.microsoft.com/office/drawing/2014/main" id="{8654D45D-CC24-719C-CB95-D82556F2E9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849273" y="6898473"/>
                <a:ext cx="4572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文本框 29">
              <a:extLst>
                <a:ext uri="{FF2B5EF4-FFF2-40B4-BE49-F238E27FC236}">
                  <a16:creationId xmlns:a16="http://schemas.microsoft.com/office/drawing/2014/main" id="{8C693A44-3C24-5F17-E9F7-377C6455C4D0}"/>
                </a:ext>
              </a:extLst>
            </p:cNvPr>
            <p:cNvSpPr txBox="1"/>
            <p:nvPr/>
          </p:nvSpPr>
          <p:spPr>
            <a:xfrm>
              <a:off x="1337931" y="6181358"/>
              <a:ext cx="196612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+       +          -         +     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+       -          +  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 -       +          -         +</a:t>
              </a:r>
            </a:p>
          </p:txBody>
        </p:sp>
        <p:sp>
          <p:nvSpPr>
            <p:cNvPr id="8" name="文本框 29">
              <a:extLst>
                <a:ext uri="{FF2B5EF4-FFF2-40B4-BE49-F238E27FC236}">
                  <a16:creationId xmlns:a16="http://schemas.microsoft.com/office/drawing/2014/main" id="{BC28E19E-A6B4-BB6B-3A03-0EBBCAB19651}"/>
                </a:ext>
              </a:extLst>
            </p:cNvPr>
            <p:cNvSpPr txBox="1"/>
            <p:nvPr/>
          </p:nvSpPr>
          <p:spPr>
            <a:xfrm>
              <a:off x="-1799860" y="6153712"/>
              <a:ext cx="166809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 beads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is-p53</a:t>
              </a:r>
              <a:r>
                <a:rPr lang="en-US" altLang="zh-CN" sz="1200" baseline="300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15-29</a:t>
              </a:r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-Mdm2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ST-CTD</a:t>
              </a:r>
            </a:p>
          </p:txBody>
        </p:sp>
        <p:cxnSp>
          <p:nvCxnSpPr>
            <p:cNvPr id="9" name="直接连接符 63">
              <a:extLst>
                <a:ext uri="{FF2B5EF4-FFF2-40B4-BE49-F238E27FC236}">
                  <a16:creationId xmlns:a16="http://schemas.microsoft.com/office/drawing/2014/main" id="{9CCEA0DF-6184-8009-1EC8-BD6BC19C39A2}"/>
                </a:ext>
              </a:extLst>
            </p:cNvPr>
            <p:cNvCxnSpPr>
              <a:cxnSpLocks/>
            </p:cNvCxnSpPr>
            <p:nvPr/>
          </p:nvCxnSpPr>
          <p:spPr>
            <a:xfrm>
              <a:off x="1183372" y="6163267"/>
              <a:ext cx="192024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文本框 13">
            <a:extLst>
              <a:ext uri="{FF2B5EF4-FFF2-40B4-BE49-F238E27FC236}">
                <a16:creationId xmlns:a16="http://schemas.microsoft.com/office/drawing/2014/main" id="{0E04E919-E90E-3297-E1D9-8B8FC3EAEC1B}"/>
              </a:ext>
            </a:extLst>
          </p:cNvPr>
          <p:cNvSpPr txBox="1"/>
          <p:nvPr/>
        </p:nvSpPr>
        <p:spPr>
          <a:xfrm>
            <a:off x="3145555" y="293923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D95F530-687F-5500-644E-6BBBB16E2B45}"/>
              </a:ext>
            </a:extLst>
          </p:cNvPr>
          <p:cNvSpPr txBox="1"/>
          <p:nvPr/>
        </p:nvSpPr>
        <p:spPr>
          <a:xfrm>
            <a:off x="3145555" y="281648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21E6CCF9-DE05-66BF-272E-25D0CCBAE0D3}"/>
              </a:ext>
            </a:extLst>
          </p:cNvPr>
          <p:cNvSpPr txBox="1"/>
          <p:nvPr/>
        </p:nvSpPr>
        <p:spPr>
          <a:xfrm>
            <a:off x="3145555" y="306278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135E973-B3BF-AD20-F47C-9D0B06998615}"/>
              </a:ext>
            </a:extLst>
          </p:cNvPr>
          <p:cNvSpPr txBox="1"/>
          <p:nvPr/>
        </p:nvSpPr>
        <p:spPr>
          <a:xfrm>
            <a:off x="3145555" y="325799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5F95BE3-14B9-B144-C149-6824E9BB0A73}"/>
              </a:ext>
            </a:extLst>
          </p:cNvPr>
          <p:cNvSpPr txBox="1"/>
          <p:nvPr/>
        </p:nvSpPr>
        <p:spPr>
          <a:xfrm>
            <a:off x="3127569" y="355177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17F4A6F-49BC-8AED-1F1E-C014D6B1C2C5}"/>
              </a:ext>
            </a:extLst>
          </p:cNvPr>
          <p:cNvSpPr txBox="1"/>
          <p:nvPr/>
        </p:nvSpPr>
        <p:spPr>
          <a:xfrm>
            <a:off x="3118708" y="379414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AD773F6-3E2D-4E85-16FE-CDBCB9CCF671}"/>
              </a:ext>
            </a:extLst>
          </p:cNvPr>
          <p:cNvSpPr txBox="1"/>
          <p:nvPr/>
        </p:nvSpPr>
        <p:spPr>
          <a:xfrm>
            <a:off x="3145555" y="267538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585D5DC1-B4BA-BEF2-2400-499374A9CB5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20" t="26506" r="23141" b="43567"/>
          <a:stretch/>
        </p:blipFill>
        <p:spPr>
          <a:xfrm>
            <a:off x="3696155" y="2331605"/>
            <a:ext cx="5703509" cy="23967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2710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8</Words>
  <Application>Microsoft Office PowerPoint</Application>
  <PresentationFormat>Widescreen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 婷</dc:creator>
  <cp:lastModifiedBy>James su</cp:lastModifiedBy>
  <cp:revision>2</cp:revision>
  <dcterms:created xsi:type="dcterms:W3CDTF">2023-01-27T03:44:48Z</dcterms:created>
  <dcterms:modified xsi:type="dcterms:W3CDTF">2023-01-27T16:57:20Z</dcterms:modified>
</cp:coreProperties>
</file>